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5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组合 72"/>
          <p:cNvGrpSpPr/>
          <p:nvPr/>
        </p:nvGrpSpPr>
        <p:grpSpPr>
          <a:xfrm>
            <a:off x="6139427" y="2502071"/>
            <a:ext cx="3209234" cy="2543520"/>
            <a:chOff x="3241472" y="2150377"/>
            <a:chExt cx="3209234" cy="254352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61" t="27155" r="9861" b="70031"/>
            <a:stretch/>
          </p:blipFill>
          <p:spPr>
            <a:xfrm>
              <a:off x="3803643" y="3126845"/>
              <a:ext cx="1896835" cy="192947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24" t="81549" r="8998" b="15638"/>
            <a:stretch/>
          </p:blipFill>
          <p:spPr>
            <a:xfrm>
              <a:off x="3803642" y="3363524"/>
              <a:ext cx="1896835" cy="192947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783" t="33747" r="9339" b="63439"/>
            <a:stretch/>
          </p:blipFill>
          <p:spPr>
            <a:xfrm>
              <a:off x="3803642" y="4223899"/>
              <a:ext cx="1896836" cy="192947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04" t="81939" r="49618" b="15248"/>
            <a:stretch/>
          </p:blipFill>
          <p:spPr>
            <a:xfrm>
              <a:off x="3803641" y="4457036"/>
              <a:ext cx="1896835" cy="192948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31" t="81904" r="8091" b="15283"/>
            <a:stretch/>
          </p:blipFill>
          <p:spPr>
            <a:xfrm>
              <a:off x="3803642" y="3600819"/>
              <a:ext cx="1896835" cy="192947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35" t="34546" r="7987" b="62641"/>
            <a:stretch/>
          </p:blipFill>
          <p:spPr>
            <a:xfrm>
              <a:off x="3803641" y="3991374"/>
              <a:ext cx="1896835" cy="192948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3803642" y="3126844"/>
              <a:ext cx="1896835" cy="1929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3241472" y="3305951"/>
              <a:ext cx="4463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W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5663951" y="3079660"/>
              <a:ext cx="666498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i="1" dirty="0"/>
                <a:t>AtFAX1</a:t>
              </a:r>
            </a:p>
          </p:txBody>
        </p:sp>
        <p:sp>
          <p:nvSpPr>
            <p:cNvPr id="11" name="矩形 10"/>
            <p:cNvSpPr/>
            <p:nvPr/>
          </p:nvSpPr>
          <p:spPr>
            <a:xfrm>
              <a:off x="3803642" y="3363524"/>
              <a:ext cx="1896835" cy="1929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矩形 12"/>
            <p:cNvSpPr/>
            <p:nvPr/>
          </p:nvSpPr>
          <p:spPr>
            <a:xfrm>
              <a:off x="3803642" y="4223899"/>
              <a:ext cx="1896835" cy="1929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3245570" y="4167378"/>
              <a:ext cx="4422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4W</a:t>
              </a:r>
            </a:p>
          </p:txBody>
        </p:sp>
        <p:sp>
          <p:nvSpPr>
            <p:cNvPr id="17" name="矩形 16"/>
            <p:cNvSpPr/>
            <p:nvPr/>
          </p:nvSpPr>
          <p:spPr>
            <a:xfrm>
              <a:off x="3803641" y="4457036"/>
              <a:ext cx="1896835" cy="1929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矩形 17"/>
            <p:cNvSpPr/>
            <p:nvPr/>
          </p:nvSpPr>
          <p:spPr>
            <a:xfrm>
              <a:off x="3803642" y="3600819"/>
              <a:ext cx="1896835" cy="1929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矩形 19"/>
            <p:cNvSpPr/>
            <p:nvPr/>
          </p:nvSpPr>
          <p:spPr>
            <a:xfrm>
              <a:off x="3803642" y="3991374"/>
              <a:ext cx="1896835" cy="1929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5651482" y="3556430"/>
              <a:ext cx="666499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i="1" dirty="0"/>
                <a:t>CsACT2</a:t>
              </a: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5663950" y="3319685"/>
              <a:ext cx="786756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i="1" dirty="0"/>
                <a:t>AtABCA9</a:t>
              </a:r>
            </a:p>
          </p:txBody>
        </p:sp>
        <p:sp>
          <p:nvSpPr>
            <p:cNvPr id="26" name="文本框 25"/>
            <p:cNvSpPr txBox="1"/>
            <p:nvPr/>
          </p:nvSpPr>
          <p:spPr>
            <a:xfrm rot="18802806">
              <a:off x="4015704" y="2739570"/>
              <a:ext cx="663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FAX1-1</a:t>
              </a:r>
            </a:p>
          </p:txBody>
        </p:sp>
        <p:sp>
          <p:nvSpPr>
            <p:cNvPr id="27" name="文本框 26"/>
            <p:cNvSpPr txBox="1"/>
            <p:nvPr/>
          </p:nvSpPr>
          <p:spPr>
            <a:xfrm rot="18802806">
              <a:off x="4287983" y="2740156"/>
              <a:ext cx="663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FAX1-2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 rot="18802806">
              <a:off x="4536571" y="2706221"/>
              <a:ext cx="7452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ABCA9-1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 rot="18802806">
              <a:off x="4810750" y="2703777"/>
              <a:ext cx="7452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ABCA9-2</a:t>
              </a:r>
            </a:p>
          </p:txBody>
        </p:sp>
        <p:sp>
          <p:nvSpPr>
            <p:cNvPr id="30" name="文本框 29"/>
            <p:cNvSpPr txBox="1"/>
            <p:nvPr/>
          </p:nvSpPr>
          <p:spPr>
            <a:xfrm rot="18802806">
              <a:off x="5020441" y="2569472"/>
              <a:ext cx="11151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ABCA9/FAX1-1</a:t>
              </a:r>
            </a:p>
          </p:txBody>
        </p:sp>
        <p:sp>
          <p:nvSpPr>
            <p:cNvPr id="31" name="文本框 30"/>
            <p:cNvSpPr txBox="1"/>
            <p:nvPr/>
          </p:nvSpPr>
          <p:spPr>
            <a:xfrm rot="18802806">
              <a:off x="5297293" y="2569472"/>
              <a:ext cx="11151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ABCA9/FAX1-2</a:t>
              </a: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3714801" y="2804446"/>
              <a:ext cx="400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WT</a:t>
              </a: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5663951" y="3948440"/>
              <a:ext cx="666498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i="1" dirty="0"/>
                <a:t>AtFAX1</a:t>
              </a: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5651482" y="4416898"/>
              <a:ext cx="666499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i="1" dirty="0"/>
                <a:t>CsACT2</a:t>
              </a: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5663950" y="4180153"/>
              <a:ext cx="786756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i="1" dirty="0"/>
                <a:t>AtABCA9</a:t>
              </a:r>
            </a:p>
          </p:txBody>
        </p:sp>
      </p:grpSp>
      <p:sp>
        <p:nvSpPr>
          <p:cNvPr id="74" name="文本框 73"/>
          <p:cNvSpPr txBox="1"/>
          <p:nvPr/>
        </p:nvSpPr>
        <p:spPr>
          <a:xfrm>
            <a:off x="5223199" y="5557397"/>
            <a:ext cx="500307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7: Figure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level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developing seeds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melina OE lines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NA was extracted from 2-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4-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ek (W) old developing seeds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used as the internal standard for cDNA input adjustment. The expression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semi-quantified by PCR with the primers specific binding to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experiment was performed at least three times with similar results.</a:t>
            </a:r>
          </a:p>
        </p:txBody>
      </p:sp>
    </p:spTree>
    <p:extLst>
      <p:ext uri="{BB962C8B-B14F-4D97-AF65-F5344CB8AC3E}">
        <p14:creationId xmlns:p14="http://schemas.microsoft.com/office/powerpoint/2010/main" val="3660197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106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41:12Z</dcterms:modified>
</cp:coreProperties>
</file>